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6"/>
  </p:notesMasterIdLst>
  <p:sldIdLst>
    <p:sldId id="258" r:id="rId2"/>
    <p:sldId id="262" r:id="rId3"/>
    <p:sldId id="264" r:id="rId4"/>
    <p:sldId id="259" r:id="rId5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5846"/>
  </p:normalViewPr>
  <p:slideViewPr>
    <p:cSldViewPr snapToGrid="0">
      <p:cViewPr varScale="1">
        <p:scale>
          <a:sx n="112" d="100"/>
          <a:sy n="112" d="100"/>
        </p:scale>
        <p:origin x="137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B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9AD7D9-45D5-EF42-B406-60266292790E}" type="datetimeFigureOut">
              <a:rPr lang="en-BR" smtClean="0"/>
              <a:t>19/09/22</a:t>
            </a:fld>
            <a:endParaRPr lang="en-B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B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06D066-6B7A-1D45-A483-ED2E2D44980C}" type="slidenum">
              <a:rPr lang="en-BR" smtClean="0"/>
              <a:t>‹#›</a:t>
            </a:fld>
            <a:endParaRPr lang="en-BR"/>
          </a:p>
        </p:txBody>
      </p:sp>
    </p:spTree>
    <p:extLst>
      <p:ext uri="{BB962C8B-B14F-4D97-AF65-F5344CB8AC3E}">
        <p14:creationId xmlns:p14="http://schemas.microsoft.com/office/powerpoint/2010/main" val="28864060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BR" dirty="0"/>
              <a:t>Female contamination </a:t>
            </a:r>
            <a:r>
              <a:rPr lang="en-BR" dirty="0">
                <a:sym typeface="Wingdings" pitchFamily="2" charset="2"/>
              </a:rPr>
              <a:t> just describe in the legend?</a:t>
            </a:r>
            <a:endParaRPr lang="en-B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A388D3-F7DD-6C4B-821A-3D2F39EFC41C}" type="slidenum">
              <a:rPr lang="en-BR" smtClean="0"/>
              <a:t>1</a:t>
            </a:fld>
            <a:endParaRPr lang="en-BR"/>
          </a:p>
        </p:txBody>
      </p:sp>
    </p:spTree>
    <p:extLst>
      <p:ext uri="{BB962C8B-B14F-4D97-AF65-F5344CB8AC3E}">
        <p14:creationId xmlns:p14="http://schemas.microsoft.com/office/powerpoint/2010/main" val="29808773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34575-0CB3-5543-8808-EA2791E0F8DA}" type="datetimeFigureOut">
              <a:rPr lang="en-BR" smtClean="0"/>
              <a:t>19/09/22</a:t>
            </a:fld>
            <a:endParaRPr lang="en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25A47-1259-F84C-B6FF-5062A763A978}" type="slidenum">
              <a:rPr lang="en-BR" smtClean="0"/>
              <a:t>‹#›</a:t>
            </a:fld>
            <a:endParaRPr lang="en-BR"/>
          </a:p>
        </p:txBody>
      </p:sp>
    </p:spTree>
    <p:extLst>
      <p:ext uri="{BB962C8B-B14F-4D97-AF65-F5344CB8AC3E}">
        <p14:creationId xmlns:p14="http://schemas.microsoft.com/office/powerpoint/2010/main" val="21255267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34575-0CB3-5543-8808-EA2791E0F8DA}" type="datetimeFigureOut">
              <a:rPr lang="en-BR" smtClean="0"/>
              <a:t>19/09/22</a:t>
            </a:fld>
            <a:endParaRPr lang="en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25A47-1259-F84C-B6FF-5062A763A978}" type="slidenum">
              <a:rPr lang="en-BR" smtClean="0"/>
              <a:t>‹#›</a:t>
            </a:fld>
            <a:endParaRPr lang="en-BR"/>
          </a:p>
        </p:txBody>
      </p:sp>
    </p:spTree>
    <p:extLst>
      <p:ext uri="{BB962C8B-B14F-4D97-AF65-F5344CB8AC3E}">
        <p14:creationId xmlns:p14="http://schemas.microsoft.com/office/powerpoint/2010/main" val="16358479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34575-0CB3-5543-8808-EA2791E0F8DA}" type="datetimeFigureOut">
              <a:rPr lang="en-BR" smtClean="0"/>
              <a:t>19/09/22</a:t>
            </a:fld>
            <a:endParaRPr lang="en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25A47-1259-F84C-B6FF-5062A763A978}" type="slidenum">
              <a:rPr lang="en-BR" smtClean="0"/>
              <a:t>‹#›</a:t>
            </a:fld>
            <a:endParaRPr lang="en-BR"/>
          </a:p>
        </p:txBody>
      </p:sp>
    </p:spTree>
    <p:extLst>
      <p:ext uri="{BB962C8B-B14F-4D97-AF65-F5344CB8AC3E}">
        <p14:creationId xmlns:p14="http://schemas.microsoft.com/office/powerpoint/2010/main" val="6491807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34575-0CB3-5543-8808-EA2791E0F8DA}" type="datetimeFigureOut">
              <a:rPr lang="en-BR" smtClean="0"/>
              <a:t>19/09/22</a:t>
            </a:fld>
            <a:endParaRPr lang="en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25A47-1259-F84C-B6FF-5062A763A978}" type="slidenum">
              <a:rPr lang="en-BR" smtClean="0"/>
              <a:t>‹#›</a:t>
            </a:fld>
            <a:endParaRPr lang="en-BR"/>
          </a:p>
        </p:txBody>
      </p:sp>
    </p:spTree>
    <p:extLst>
      <p:ext uri="{BB962C8B-B14F-4D97-AF65-F5344CB8AC3E}">
        <p14:creationId xmlns:p14="http://schemas.microsoft.com/office/powerpoint/2010/main" val="1616221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34575-0CB3-5543-8808-EA2791E0F8DA}" type="datetimeFigureOut">
              <a:rPr lang="en-BR" smtClean="0"/>
              <a:t>19/09/22</a:t>
            </a:fld>
            <a:endParaRPr lang="en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25A47-1259-F84C-B6FF-5062A763A978}" type="slidenum">
              <a:rPr lang="en-BR" smtClean="0"/>
              <a:t>‹#›</a:t>
            </a:fld>
            <a:endParaRPr lang="en-BR"/>
          </a:p>
        </p:txBody>
      </p:sp>
    </p:spTree>
    <p:extLst>
      <p:ext uri="{BB962C8B-B14F-4D97-AF65-F5344CB8AC3E}">
        <p14:creationId xmlns:p14="http://schemas.microsoft.com/office/powerpoint/2010/main" val="26114479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34575-0CB3-5543-8808-EA2791E0F8DA}" type="datetimeFigureOut">
              <a:rPr lang="en-BR" smtClean="0"/>
              <a:t>19/09/22</a:t>
            </a:fld>
            <a:endParaRPr lang="en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25A47-1259-F84C-B6FF-5062A763A978}" type="slidenum">
              <a:rPr lang="en-BR" smtClean="0"/>
              <a:t>‹#›</a:t>
            </a:fld>
            <a:endParaRPr lang="en-BR"/>
          </a:p>
        </p:txBody>
      </p:sp>
    </p:spTree>
    <p:extLst>
      <p:ext uri="{BB962C8B-B14F-4D97-AF65-F5344CB8AC3E}">
        <p14:creationId xmlns:p14="http://schemas.microsoft.com/office/powerpoint/2010/main" val="93486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34575-0CB3-5543-8808-EA2791E0F8DA}" type="datetimeFigureOut">
              <a:rPr lang="en-BR" smtClean="0"/>
              <a:t>19/09/22</a:t>
            </a:fld>
            <a:endParaRPr lang="en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25A47-1259-F84C-B6FF-5062A763A978}" type="slidenum">
              <a:rPr lang="en-BR" smtClean="0"/>
              <a:t>‹#›</a:t>
            </a:fld>
            <a:endParaRPr lang="en-BR"/>
          </a:p>
        </p:txBody>
      </p:sp>
    </p:spTree>
    <p:extLst>
      <p:ext uri="{BB962C8B-B14F-4D97-AF65-F5344CB8AC3E}">
        <p14:creationId xmlns:p14="http://schemas.microsoft.com/office/powerpoint/2010/main" val="37504146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34575-0CB3-5543-8808-EA2791E0F8DA}" type="datetimeFigureOut">
              <a:rPr lang="en-BR" smtClean="0"/>
              <a:t>19/09/22</a:t>
            </a:fld>
            <a:endParaRPr lang="en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25A47-1259-F84C-B6FF-5062A763A978}" type="slidenum">
              <a:rPr lang="en-BR" smtClean="0"/>
              <a:t>‹#›</a:t>
            </a:fld>
            <a:endParaRPr lang="en-BR"/>
          </a:p>
        </p:txBody>
      </p:sp>
    </p:spTree>
    <p:extLst>
      <p:ext uri="{BB962C8B-B14F-4D97-AF65-F5344CB8AC3E}">
        <p14:creationId xmlns:p14="http://schemas.microsoft.com/office/powerpoint/2010/main" val="19490534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34575-0CB3-5543-8808-EA2791E0F8DA}" type="datetimeFigureOut">
              <a:rPr lang="en-BR" smtClean="0"/>
              <a:t>19/09/22</a:t>
            </a:fld>
            <a:endParaRPr lang="en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25A47-1259-F84C-B6FF-5062A763A978}" type="slidenum">
              <a:rPr lang="en-BR" smtClean="0"/>
              <a:t>‹#›</a:t>
            </a:fld>
            <a:endParaRPr lang="en-BR"/>
          </a:p>
        </p:txBody>
      </p:sp>
    </p:spTree>
    <p:extLst>
      <p:ext uri="{BB962C8B-B14F-4D97-AF65-F5344CB8AC3E}">
        <p14:creationId xmlns:p14="http://schemas.microsoft.com/office/powerpoint/2010/main" val="37018934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34575-0CB3-5543-8808-EA2791E0F8DA}" type="datetimeFigureOut">
              <a:rPr lang="en-BR" smtClean="0"/>
              <a:t>19/09/22</a:t>
            </a:fld>
            <a:endParaRPr lang="en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25A47-1259-F84C-B6FF-5062A763A978}" type="slidenum">
              <a:rPr lang="en-BR" smtClean="0"/>
              <a:t>‹#›</a:t>
            </a:fld>
            <a:endParaRPr lang="en-BR"/>
          </a:p>
        </p:txBody>
      </p:sp>
    </p:spTree>
    <p:extLst>
      <p:ext uri="{BB962C8B-B14F-4D97-AF65-F5344CB8AC3E}">
        <p14:creationId xmlns:p14="http://schemas.microsoft.com/office/powerpoint/2010/main" val="10065382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34575-0CB3-5543-8808-EA2791E0F8DA}" type="datetimeFigureOut">
              <a:rPr lang="en-BR" smtClean="0"/>
              <a:t>19/09/22</a:t>
            </a:fld>
            <a:endParaRPr lang="en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25A47-1259-F84C-B6FF-5062A763A978}" type="slidenum">
              <a:rPr lang="en-BR" smtClean="0"/>
              <a:t>‹#›</a:t>
            </a:fld>
            <a:endParaRPr lang="en-BR"/>
          </a:p>
        </p:txBody>
      </p:sp>
    </p:spTree>
    <p:extLst>
      <p:ext uri="{BB962C8B-B14F-4D97-AF65-F5344CB8AC3E}">
        <p14:creationId xmlns:p14="http://schemas.microsoft.com/office/powerpoint/2010/main" val="1674841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934575-0CB3-5543-8808-EA2791E0F8DA}" type="datetimeFigureOut">
              <a:rPr lang="en-BR" smtClean="0"/>
              <a:t>19/09/22</a:t>
            </a:fld>
            <a:endParaRPr lang="en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A25A47-1259-F84C-B6FF-5062A763A978}" type="slidenum">
              <a:rPr lang="en-BR" smtClean="0"/>
              <a:t>‹#›</a:t>
            </a:fld>
            <a:endParaRPr lang="en-BR"/>
          </a:p>
        </p:txBody>
      </p:sp>
    </p:spTree>
    <p:extLst>
      <p:ext uri="{BB962C8B-B14F-4D97-AF65-F5344CB8AC3E}">
        <p14:creationId xmlns:p14="http://schemas.microsoft.com/office/powerpoint/2010/main" val="27824710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tiff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3914D954-D452-3E95-42BE-4D13A731C0C2}"/>
              </a:ext>
            </a:extLst>
          </p:cNvPr>
          <p:cNvSpPr txBox="1"/>
          <p:nvPr/>
        </p:nvSpPr>
        <p:spPr>
          <a:xfrm>
            <a:off x="947048" y="1426351"/>
            <a:ext cx="293670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R" sz="1463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05F054A-DBEA-9C35-5853-E7D745A56819}"/>
              </a:ext>
            </a:extLst>
          </p:cNvPr>
          <p:cNvSpPr txBox="1"/>
          <p:nvPr/>
        </p:nvSpPr>
        <p:spPr>
          <a:xfrm>
            <a:off x="3931413" y="1376836"/>
            <a:ext cx="287258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R" sz="1463" dirty="0"/>
              <a:t>B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80BB8CF0-43ED-AE27-11B6-D81FA4BE3BE4}"/>
              </a:ext>
            </a:extLst>
          </p:cNvPr>
          <p:cNvGrpSpPr/>
          <p:nvPr/>
        </p:nvGrpSpPr>
        <p:grpSpPr>
          <a:xfrm>
            <a:off x="1285048" y="1426353"/>
            <a:ext cx="2579173" cy="2443723"/>
            <a:chOff x="1944480" y="332439"/>
            <a:chExt cx="2933421" cy="2876633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91FBE54E-C605-06F3-3EE6-55E9DA44F4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0911" r="16148" b="3217"/>
            <a:stretch/>
          </p:blipFill>
          <p:spPr>
            <a:xfrm rot="5400000">
              <a:off x="1986812" y="317982"/>
              <a:ext cx="2850720" cy="2931459"/>
            </a:xfrm>
            <a:prstGeom prst="rect">
              <a:avLst/>
            </a:prstGeom>
          </p:spPr>
        </p:pic>
        <p:pic>
          <p:nvPicPr>
            <p:cNvPr id="1026" name="Picture 2" descr="Ortigueira | VIAJE PARANÁ">
              <a:extLst>
                <a:ext uri="{FF2B5EF4-FFF2-40B4-BE49-F238E27FC236}">
                  <a16:creationId xmlns:a16="http://schemas.microsoft.com/office/drawing/2014/main" id="{E490F548-8FE4-1A88-CC4A-93E85B37006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44480" y="332439"/>
              <a:ext cx="1191235" cy="95728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pic>
        <p:nvPicPr>
          <p:cNvPr id="7" name="Picture 6">
            <a:extLst>
              <a:ext uri="{FF2B5EF4-FFF2-40B4-BE49-F238E27FC236}">
                <a16:creationId xmlns:a16="http://schemas.microsoft.com/office/drawing/2014/main" id="{F1D0B646-E165-0913-8982-F475AFEA1F5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99938" y="1558674"/>
            <a:ext cx="5365750" cy="23114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70928BC-AEFB-5374-7BA8-EE6D27224CC9}"/>
              </a:ext>
            </a:extLst>
          </p:cNvPr>
          <p:cNvSpPr txBox="1"/>
          <p:nvPr/>
        </p:nvSpPr>
        <p:spPr>
          <a:xfrm>
            <a:off x="789384" y="4067098"/>
            <a:ext cx="8420583" cy="18933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63" b="1" dirty="0"/>
              <a:t>Figure S1. A. Map of </a:t>
            </a:r>
            <a:r>
              <a:rPr lang="en-US" sz="1463" b="1" dirty="0" err="1"/>
              <a:t>Ortigueira</a:t>
            </a:r>
            <a:r>
              <a:rPr lang="en-US" sz="1463" b="1" dirty="0"/>
              <a:t>. </a:t>
            </a:r>
            <a:r>
              <a:rPr lang="en-US" sz="1463" dirty="0"/>
              <a:t>The city is located in Paraná State, southern of Brazil. White marks show the points where </a:t>
            </a:r>
            <a:r>
              <a:rPr lang="en-US" sz="1463" dirty="0" err="1"/>
              <a:t>ovitraps</a:t>
            </a:r>
            <a:r>
              <a:rPr lang="en-US" sz="1463" dirty="0"/>
              <a:t> were installed for mosquito monitoring. </a:t>
            </a:r>
            <a:r>
              <a:rPr lang="en-US" sz="1463" b="1" dirty="0"/>
              <a:t>B. </a:t>
            </a:r>
            <a:r>
              <a:rPr lang="en-US" sz="1463" dirty="0"/>
              <a:t>Number of NVC mosquitoes monthly released in </a:t>
            </a:r>
            <a:r>
              <a:rPr lang="en-US" sz="1463" dirty="0" err="1"/>
              <a:t>Ortigueira</a:t>
            </a:r>
            <a:r>
              <a:rPr lang="en-US" sz="1463" dirty="0"/>
              <a:t> during the NVC intervention, starting on Dec 2020. A total of 52 million sterile male mosquitoes were released. </a:t>
            </a:r>
          </a:p>
          <a:p>
            <a:pPr algn="just"/>
            <a:endParaRPr lang="en-US" sz="1463" b="1" dirty="0"/>
          </a:p>
          <a:p>
            <a:pPr algn="just"/>
            <a:endParaRPr lang="en-US" sz="1463" dirty="0"/>
          </a:p>
          <a:p>
            <a:pPr algn="just"/>
            <a:endParaRPr lang="en-US" sz="1463" dirty="0"/>
          </a:p>
          <a:p>
            <a:pPr algn="just"/>
            <a:endParaRPr lang="en-BR" sz="1463" dirty="0"/>
          </a:p>
        </p:txBody>
      </p:sp>
    </p:spTree>
    <p:extLst>
      <p:ext uri="{BB962C8B-B14F-4D97-AF65-F5344CB8AC3E}">
        <p14:creationId xmlns:p14="http://schemas.microsoft.com/office/powerpoint/2010/main" val="4794810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8B1BBA7A-568E-4102-8EDA-760AD62B9E4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8157"/>
          <a:stretch/>
        </p:blipFill>
        <p:spPr>
          <a:xfrm>
            <a:off x="2302255" y="1349938"/>
            <a:ext cx="5301491" cy="323827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554D444-4A55-C44D-9DB2-7B1596E91811}"/>
              </a:ext>
            </a:extLst>
          </p:cNvPr>
          <p:cNvSpPr txBox="1"/>
          <p:nvPr/>
        </p:nvSpPr>
        <p:spPr>
          <a:xfrm>
            <a:off x="1402320" y="4715159"/>
            <a:ext cx="7160181" cy="9928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BR" sz="1463" b="1" dirty="0"/>
              <a:t>Figure S2.</a:t>
            </a:r>
            <a:r>
              <a:rPr lang="en-BR" sz="1463" dirty="0"/>
              <a:t> Correlation between releases of NVC sterile male mosquitoes and viable progeny. A linear regression ana</a:t>
            </a:r>
            <a:r>
              <a:rPr lang="en-US" sz="1463" dirty="0"/>
              <a:t>lysis was performed to verify the dependence between mean of viable progeny and amount of NVC mosquitoes released. P &lt;0.005, R</a:t>
            </a:r>
            <a:r>
              <a:rPr lang="en-US" sz="1463" baseline="30000" dirty="0"/>
              <a:t>2</a:t>
            </a:r>
            <a:r>
              <a:rPr lang="en-US" sz="1463" dirty="0"/>
              <a:t>=0.567.</a:t>
            </a:r>
          </a:p>
          <a:p>
            <a:pPr algn="just"/>
            <a:r>
              <a:rPr lang="en-BR" sz="1463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5215903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C8409227-E305-6F54-2EBC-0DD04E28E69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81750048"/>
              </p:ext>
            </p:extLst>
          </p:nvPr>
        </p:nvGraphicFramePr>
        <p:xfrm>
          <a:off x="200543" y="1839212"/>
          <a:ext cx="9420031" cy="3085131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849487">
                  <a:extLst>
                    <a:ext uri="{9D8B030D-6E8A-4147-A177-3AD203B41FA5}">
                      <a16:colId xmlns:a16="http://schemas.microsoft.com/office/drawing/2014/main" val="4009990901"/>
                    </a:ext>
                  </a:extLst>
                </a:gridCol>
                <a:gridCol w="782580">
                  <a:extLst>
                    <a:ext uri="{9D8B030D-6E8A-4147-A177-3AD203B41FA5}">
                      <a16:colId xmlns:a16="http://schemas.microsoft.com/office/drawing/2014/main" val="902056556"/>
                    </a:ext>
                  </a:extLst>
                </a:gridCol>
                <a:gridCol w="685165">
                  <a:extLst>
                    <a:ext uri="{9D8B030D-6E8A-4147-A177-3AD203B41FA5}">
                      <a16:colId xmlns:a16="http://schemas.microsoft.com/office/drawing/2014/main" val="2873699157"/>
                    </a:ext>
                  </a:extLst>
                </a:gridCol>
                <a:gridCol w="949325">
                  <a:extLst>
                    <a:ext uri="{9D8B030D-6E8A-4147-A177-3AD203B41FA5}">
                      <a16:colId xmlns:a16="http://schemas.microsoft.com/office/drawing/2014/main" val="2979319677"/>
                    </a:ext>
                  </a:extLst>
                </a:gridCol>
                <a:gridCol w="487045">
                  <a:extLst>
                    <a:ext uri="{9D8B030D-6E8A-4147-A177-3AD203B41FA5}">
                      <a16:colId xmlns:a16="http://schemas.microsoft.com/office/drawing/2014/main" val="99451965"/>
                    </a:ext>
                  </a:extLst>
                </a:gridCol>
                <a:gridCol w="858520">
                  <a:extLst>
                    <a:ext uri="{9D8B030D-6E8A-4147-A177-3AD203B41FA5}">
                      <a16:colId xmlns:a16="http://schemas.microsoft.com/office/drawing/2014/main" val="2342562629"/>
                    </a:ext>
                  </a:extLst>
                </a:gridCol>
                <a:gridCol w="875030">
                  <a:extLst>
                    <a:ext uri="{9D8B030D-6E8A-4147-A177-3AD203B41FA5}">
                      <a16:colId xmlns:a16="http://schemas.microsoft.com/office/drawing/2014/main" val="2234942144"/>
                    </a:ext>
                  </a:extLst>
                </a:gridCol>
                <a:gridCol w="586105">
                  <a:extLst>
                    <a:ext uri="{9D8B030D-6E8A-4147-A177-3AD203B41FA5}">
                      <a16:colId xmlns:a16="http://schemas.microsoft.com/office/drawing/2014/main" val="3485313390"/>
                    </a:ext>
                  </a:extLst>
                </a:gridCol>
                <a:gridCol w="974090">
                  <a:extLst>
                    <a:ext uri="{9D8B030D-6E8A-4147-A177-3AD203B41FA5}">
                      <a16:colId xmlns:a16="http://schemas.microsoft.com/office/drawing/2014/main" val="3337948842"/>
                    </a:ext>
                  </a:extLst>
                </a:gridCol>
                <a:gridCol w="647528">
                  <a:extLst>
                    <a:ext uri="{9D8B030D-6E8A-4147-A177-3AD203B41FA5}">
                      <a16:colId xmlns:a16="http://schemas.microsoft.com/office/drawing/2014/main" val="3246639852"/>
                    </a:ext>
                  </a:extLst>
                </a:gridCol>
                <a:gridCol w="912285">
                  <a:extLst>
                    <a:ext uri="{9D8B030D-6E8A-4147-A177-3AD203B41FA5}">
                      <a16:colId xmlns:a16="http://schemas.microsoft.com/office/drawing/2014/main" val="1061663140"/>
                    </a:ext>
                  </a:extLst>
                </a:gridCol>
                <a:gridCol w="812871">
                  <a:extLst>
                    <a:ext uri="{9D8B030D-6E8A-4147-A177-3AD203B41FA5}">
                      <a16:colId xmlns:a16="http://schemas.microsoft.com/office/drawing/2014/main" val="698389600"/>
                    </a:ext>
                  </a:extLst>
                </a:gridCol>
              </a:tblGrid>
              <a:tr h="599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City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>
                          <a:effectLst/>
                        </a:rPr>
                        <a:t>Territorial area (Km2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>
                          <a:effectLst/>
                        </a:rPr>
                        <a:t>Population 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>
                          <a:effectLst/>
                        </a:rPr>
                        <a:t>Demographic density (inhabitants/km2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HDI* 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>
                          <a:effectLst/>
                        </a:rPr>
                        <a:t>GDP per capita (reais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>
                          <a:effectLst/>
                        </a:rPr>
                        <a:t>Temperature variation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 err="1">
                          <a:effectLst/>
                        </a:rPr>
                        <a:t>Umidity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>
                          <a:effectLst/>
                        </a:rPr>
                        <a:t>Rain preciptation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Climate**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>
                          <a:effectLst/>
                        </a:rPr>
                        <a:t>Bioma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Altitude (meters)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ctr"/>
                </a:tc>
                <a:extLst>
                  <a:ext uri="{0D108BD9-81ED-4DB2-BD59-A6C34878D82A}">
                    <a16:rowId xmlns:a16="http://schemas.microsoft.com/office/drawing/2014/main" val="3391238708"/>
                  </a:ext>
                </a:extLst>
              </a:tr>
              <a:tr h="24855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pucara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558,389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134,996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216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0,748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25,602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BR" sz="900" u="none" strike="noStrike">
                          <a:effectLst/>
                        </a:rPr>
                        <a:t>20,1-21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70-75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1,700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STH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luvia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860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extLst>
                  <a:ext uri="{0D108BD9-81ED-4DB2-BD59-A6C34878D82A}">
                    <a16:rowId xmlns:a16="http://schemas.microsoft.com/office/drawing/2014/main" val="347272175"/>
                  </a:ext>
                </a:extLst>
              </a:tr>
              <a:tr h="24855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Grandes Rio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314,198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5,618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21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0,658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20,909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BR" sz="900" u="none" strike="noStrike">
                          <a:effectLst/>
                        </a:rPr>
                        <a:t>20,1-21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70-75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1,700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STH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luvia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700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extLst>
                  <a:ext uri="{0D108BD9-81ED-4DB2-BD59-A6C34878D82A}">
                    <a16:rowId xmlns:a16="http://schemas.microsoft.com/office/drawing/2014/main" val="586801532"/>
                  </a:ext>
                </a:extLst>
              </a:tr>
              <a:tr h="24855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mbaú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330,703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13,111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34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0,622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16,574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BR" sz="900" u="none" strike="noStrike">
                          <a:effectLst/>
                        </a:rPr>
                        <a:t>18,1-19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75-80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1,700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STH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raucári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940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extLst>
                  <a:ext uri="{0D108BD9-81ED-4DB2-BD59-A6C34878D82A}">
                    <a16:rowId xmlns:a16="http://schemas.microsoft.com/office/drawing/2014/main" val="4268525255"/>
                  </a:ext>
                </a:extLst>
              </a:tr>
              <a:tr h="24855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Londri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1652,569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569,733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307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0,778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37,912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BR" sz="900" u="none" strike="noStrike">
                          <a:effectLst/>
                        </a:rPr>
                        <a:t>21,1-22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70-75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1,700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STH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luvia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610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extLst>
                  <a:ext uri="{0D108BD9-81ED-4DB2-BD59-A6C34878D82A}">
                    <a16:rowId xmlns:a16="http://schemas.microsoft.com/office/drawing/2014/main" val="3664807380"/>
                  </a:ext>
                </a:extLst>
              </a:tr>
              <a:tr h="24855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err="1">
                          <a:effectLst/>
                        </a:rPr>
                        <a:t>Marilândia</a:t>
                      </a:r>
                      <a:r>
                        <a:rPr lang="en-US" sz="900" u="none" strike="noStrike" dirty="0">
                          <a:effectLst/>
                        </a:rPr>
                        <a:t> do Su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384,424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8,836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23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0,691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36,487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BR" sz="900" u="none" strike="noStrike">
                          <a:effectLst/>
                        </a:rPr>
                        <a:t>20,1-21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70-75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1,700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STH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luvia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760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extLst>
                  <a:ext uri="{0D108BD9-81ED-4DB2-BD59-A6C34878D82A}">
                    <a16:rowId xmlns:a16="http://schemas.microsoft.com/office/drawing/2014/main" val="2224086534"/>
                  </a:ext>
                </a:extLst>
              </a:tr>
              <a:tr h="24855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auá da Serr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108,324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10,601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79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0,652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29,157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BR" sz="900" u="none" strike="noStrike">
                          <a:effectLst/>
                        </a:rPr>
                        <a:t>19,1-20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70-75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1,700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STH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raucári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1030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extLst>
                  <a:ext uri="{0D108BD9-81ED-4DB2-BD59-A6C34878D82A}">
                    <a16:rowId xmlns:a16="http://schemas.microsoft.com/office/drawing/2014/main" val="4127530171"/>
                  </a:ext>
                </a:extLst>
              </a:tr>
              <a:tr h="24855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Ortigueir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 dirty="0">
                          <a:effectLst/>
                        </a:rPr>
                        <a:t>2429,564</a:t>
                      </a:r>
                      <a:endParaRPr lang="en-B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22,141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10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0,609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 dirty="0">
                          <a:effectLst/>
                        </a:rPr>
                        <a:t>131,023</a:t>
                      </a:r>
                      <a:endParaRPr lang="en-B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BR" sz="900" u="none" strike="noStrike" dirty="0">
                          <a:effectLst/>
                        </a:rPr>
                        <a:t>19,1-20</a:t>
                      </a:r>
                      <a:endParaRPr lang="en-B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75-80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1,700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STH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raucári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750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extLst>
                  <a:ext uri="{0D108BD9-81ED-4DB2-BD59-A6C34878D82A}">
                    <a16:rowId xmlns:a16="http://schemas.microsoft.com/office/drawing/2014/main" val="2050979517"/>
                  </a:ext>
                </a:extLst>
              </a:tr>
              <a:tr h="24855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Tamara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472,155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14,797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26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0,621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20,244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BR" sz="900" u="none" strike="noStrike">
                          <a:effectLst/>
                        </a:rPr>
                        <a:t>20,1-21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70-75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1,700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STH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luvia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750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extLst>
                  <a:ext uri="{0D108BD9-81ED-4DB2-BD59-A6C34878D82A}">
                    <a16:rowId xmlns:a16="http://schemas.microsoft.com/office/drawing/2014/main" val="1257640342"/>
                  </a:ext>
                </a:extLst>
              </a:tr>
              <a:tr h="24855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Telêmaco Borb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1382,861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78,974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51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0,734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45,262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BR" sz="900" u="none" strike="noStrike">
                          <a:effectLst/>
                        </a:rPr>
                        <a:t>19,1-20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75-80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1,700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STH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raucári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740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extLst>
                  <a:ext uri="{0D108BD9-81ED-4DB2-BD59-A6C34878D82A}">
                    <a16:rowId xmlns:a16="http://schemas.microsoft.com/office/drawing/2014/main" val="913998914"/>
                  </a:ext>
                </a:extLst>
              </a:tr>
              <a:tr h="24855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err="1">
                          <a:effectLst/>
                        </a:rPr>
                        <a:t>Tibagi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 dirty="0">
                          <a:effectLst/>
                        </a:rPr>
                        <a:t>2951,567</a:t>
                      </a:r>
                      <a:endParaRPr lang="en-B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20,522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 dirty="0">
                          <a:effectLst/>
                        </a:rPr>
                        <a:t>7</a:t>
                      </a:r>
                      <a:endParaRPr lang="en-B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0,664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41,034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BR" sz="900" u="none" strike="noStrike">
                          <a:effectLst/>
                        </a:rPr>
                        <a:t>18,1-19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75-80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>
                          <a:effectLst/>
                        </a:rPr>
                        <a:t>1,700</a:t>
                      </a:r>
                      <a:endParaRPr lang="en-B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STM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ampo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BR" sz="900" u="none" strike="noStrike" dirty="0">
                          <a:effectLst/>
                        </a:rPr>
                        <a:t>720</a:t>
                      </a:r>
                      <a:endParaRPr lang="en-B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654" marR="6654" marT="6654" marB="0" anchor="b"/>
                </a:tc>
                <a:extLst>
                  <a:ext uri="{0D108BD9-81ED-4DB2-BD59-A6C34878D82A}">
                    <a16:rowId xmlns:a16="http://schemas.microsoft.com/office/drawing/2014/main" val="3056292761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11A23CA1-4F82-F069-1764-57D3AE2B0E50}"/>
              </a:ext>
            </a:extLst>
          </p:cNvPr>
          <p:cNvSpPr txBox="1"/>
          <p:nvPr/>
        </p:nvSpPr>
        <p:spPr>
          <a:xfrm>
            <a:off x="125599" y="4961836"/>
            <a:ext cx="5012911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R" sz="975" dirty="0"/>
              <a:t>*HDI: Human development Index</a:t>
            </a:r>
          </a:p>
          <a:p>
            <a:r>
              <a:rPr lang="en-US" sz="975" dirty="0"/>
              <a:t>**STHS: Subtropical climate, with hot summers; STMS: Subtropical climate, with mild summers</a:t>
            </a:r>
            <a:endParaRPr lang="en-US" sz="975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124DBBB-F771-09BD-AB56-603ACB26D897}"/>
              </a:ext>
            </a:extLst>
          </p:cNvPr>
          <p:cNvSpPr txBox="1"/>
          <p:nvPr/>
        </p:nvSpPr>
        <p:spPr>
          <a:xfrm>
            <a:off x="125600" y="1324629"/>
            <a:ext cx="9780401" cy="7677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63" b="1" dirty="0"/>
              <a:t>Table S3. Climate and demographic characteristics of </a:t>
            </a:r>
            <a:r>
              <a:rPr lang="en-US" sz="1463" b="1" dirty="0" err="1"/>
              <a:t>Ortigueira</a:t>
            </a:r>
            <a:r>
              <a:rPr lang="en-US" sz="1463" b="1" dirty="0"/>
              <a:t> and the neighboring cities (Source: Brazil population census). </a:t>
            </a:r>
          </a:p>
          <a:p>
            <a:endParaRPr lang="en-BR" sz="1463" dirty="0"/>
          </a:p>
        </p:txBody>
      </p:sp>
    </p:spTree>
    <p:extLst>
      <p:ext uri="{BB962C8B-B14F-4D97-AF65-F5344CB8AC3E}">
        <p14:creationId xmlns:p14="http://schemas.microsoft.com/office/powerpoint/2010/main" val="5748720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7F1DA9CC-942F-9917-88BE-83976D78006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1866"/>
          <a:stretch/>
        </p:blipFill>
        <p:spPr>
          <a:xfrm>
            <a:off x="2422155" y="823755"/>
            <a:ext cx="4345667" cy="23114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0ED25932-220A-B016-FE49-674A7100E06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3287"/>
          <a:stretch/>
        </p:blipFill>
        <p:spPr>
          <a:xfrm>
            <a:off x="2432472" y="2958125"/>
            <a:ext cx="4258742" cy="2352675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C9FC13E6-53BE-2126-CBBB-B59C3BFE0AD9}"/>
              </a:ext>
            </a:extLst>
          </p:cNvPr>
          <p:cNvSpPr txBox="1"/>
          <p:nvPr/>
        </p:nvSpPr>
        <p:spPr>
          <a:xfrm>
            <a:off x="2425970" y="642940"/>
            <a:ext cx="336952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R" sz="1950" b="1" dirty="0"/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6BF4523-E2DD-9E79-D0DA-7791C2DDB3A7}"/>
              </a:ext>
            </a:extLst>
          </p:cNvPr>
          <p:cNvSpPr txBox="1"/>
          <p:nvPr/>
        </p:nvSpPr>
        <p:spPr>
          <a:xfrm>
            <a:off x="2423364" y="2835844"/>
            <a:ext cx="324128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BR" sz="1950" b="1" dirty="0"/>
              <a:t>B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48058CC-EDA0-9111-5F2E-1CE80B53662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5908"/>
          <a:stretch/>
        </p:blipFill>
        <p:spPr>
          <a:xfrm>
            <a:off x="6624027" y="1650324"/>
            <a:ext cx="1339964" cy="23114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A08F883-A5E8-1932-A3F2-2242BBFEDADD}"/>
              </a:ext>
            </a:extLst>
          </p:cNvPr>
          <p:cNvSpPr txBox="1"/>
          <p:nvPr/>
        </p:nvSpPr>
        <p:spPr>
          <a:xfrm>
            <a:off x="2068209" y="5014827"/>
            <a:ext cx="6382848" cy="9928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63" b="1" dirty="0"/>
              <a:t>Figure S4. Historical arboviruses incidence in </a:t>
            </a:r>
            <a:r>
              <a:rPr lang="en-US" sz="1463" b="1" dirty="0" err="1"/>
              <a:t>Ortigueira</a:t>
            </a:r>
            <a:r>
              <a:rPr lang="en-US" sz="1463" b="1" dirty="0"/>
              <a:t> vs neighboring cities. </a:t>
            </a:r>
            <a:r>
              <a:rPr lang="en-US" sz="1463" dirty="0"/>
              <a:t>Chikungunya (A) and Zika (B) incidence from 2014 to 2022 (displayed as cases per 100,000 inhabitants) in </a:t>
            </a:r>
            <a:r>
              <a:rPr lang="en-US" sz="1463" dirty="0" err="1"/>
              <a:t>Ortigueira</a:t>
            </a:r>
            <a:r>
              <a:rPr lang="en-US" sz="1463" dirty="0"/>
              <a:t> and other 10 neighboring cities, as indicated. Data source: Brazilian National Disease Surveillance System (SINAN). </a:t>
            </a:r>
            <a:endParaRPr lang="en-BR" sz="1463" dirty="0"/>
          </a:p>
        </p:txBody>
      </p:sp>
    </p:spTree>
    <p:extLst>
      <p:ext uri="{BB962C8B-B14F-4D97-AF65-F5344CB8AC3E}">
        <p14:creationId xmlns:p14="http://schemas.microsoft.com/office/powerpoint/2010/main" val="17053605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384</Words>
  <Application>Microsoft Macintosh PowerPoint</Application>
  <PresentationFormat>A4 Paper (210x297 mm)</PresentationFormat>
  <Paragraphs>147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se lopes</dc:creator>
  <cp:lastModifiedBy>marise lopes</cp:lastModifiedBy>
  <cp:revision>2</cp:revision>
  <dcterms:created xsi:type="dcterms:W3CDTF">2022-09-14T10:33:03Z</dcterms:created>
  <dcterms:modified xsi:type="dcterms:W3CDTF">2022-09-19T15:24:24Z</dcterms:modified>
</cp:coreProperties>
</file>